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/>
    <p:restoredTop sz="94684"/>
  </p:normalViewPr>
  <p:slideViewPr>
    <p:cSldViewPr snapToGrid="0">
      <p:cViewPr varScale="1">
        <p:scale>
          <a:sx n="106" d="100"/>
          <a:sy n="106" d="100"/>
        </p:scale>
        <p:origin x="79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F1D7AF7-3924-C96F-FE69-4642D3AFFFE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D6B950A0-26FC-9346-2B02-390CC276CA8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F0702DE-8D92-6485-E70D-DD361F3CF3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3BC50-C58B-A94F-AD0C-E7543555C2CA}" type="datetimeFigureOut">
              <a:rPr lang="it-IT" smtClean="0"/>
              <a:t>11/08/23</a:t>
            </a:fld>
            <a:endParaRPr lang="it-IT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F974DF7-B999-738C-B12D-FBCBED954D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3C2A742-AB6D-B1D9-86F1-4EAB0C26E9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AF65E-4640-4E49-A662-37B11C382FE0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4409651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DE3CFA6-DB63-213C-1C77-70C2AE33A5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E0CBD8A6-9A92-E9EE-6884-04A2688D8A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286075C-C6C4-1FEB-B762-63660399DB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3BC50-C58B-A94F-AD0C-E7543555C2CA}" type="datetimeFigureOut">
              <a:rPr lang="it-IT" smtClean="0"/>
              <a:t>11/08/23</a:t>
            </a:fld>
            <a:endParaRPr lang="it-IT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2A8DDED-1F06-3F1A-A9F0-C92C832DDE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1893BBE-57CE-D504-A443-A4D38B42A8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AF65E-4640-4E49-A662-37B11C382FE0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40998868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A2E88A4D-7F22-9B96-2F36-41E13CE0476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059CC40A-37DB-C096-6C24-C7FB74AA4A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F9799C6-CD2F-1E0D-80B5-C8A397AEBB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3BC50-C58B-A94F-AD0C-E7543555C2CA}" type="datetimeFigureOut">
              <a:rPr lang="it-IT" smtClean="0"/>
              <a:t>11/08/23</a:t>
            </a:fld>
            <a:endParaRPr lang="it-IT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652DF9B-D5E0-9753-E2EB-46A65CF462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CDDADE1-4F46-8D7D-087E-F2EAE52EF1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AF65E-4640-4E49-A662-37B11C382FE0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6143340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0E3DD28-FC66-6036-E4DC-9365A733A8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58E4F37-18F1-DEB8-37C6-B7E29EE852C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EA02EFE-3951-9EFD-73DA-7AAC699FE3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3BC50-C58B-A94F-AD0C-E7543555C2CA}" type="datetimeFigureOut">
              <a:rPr lang="it-IT" smtClean="0"/>
              <a:t>11/08/23</a:t>
            </a:fld>
            <a:endParaRPr lang="it-IT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8FECA83-1DEE-9874-CFCA-8D92423B1C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31DC491-3510-FD09-26F0-FF60535A2C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AF65E-4640-4E49-A662-37B11C382FE0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4148212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D31A9E7-001E-B8B1-AB76-EC15EA3351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B10CA0E-8F10-108D-AA20-50AF8E00EA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6B950F9-DA77-6198-47DD-D58CB79E8A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3BC50-C58B-A94F-AD0C-E7543555C2CA}" type="datetimeFigureOut">
              <a:rPr lang="it-IT" smtClean="0"/>
              <a:t>11/08/23</a:t>
            </a:fld>
            <a:endParaRPr lang="it-IT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EC72C68-67CB-4A91-40BE-7475E9D723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910F8A5-FB33-470D-5580-0FACBB0209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AF65E-4640-4E49-A662-37B11C382FE0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158942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6C2E3F0-2D21-B3DC-4079-A14928BBC9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E577E44-9F09-54F0-9FFA-57AEB11A1EF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E2B6E7BF-1CB9-9DE6-7B92-5B616F06D9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48112C0-F7AD-680C-5562-151EE3A695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3BC50-C58B-A94F-AD0C-E7543555C2CA}" type="datetimeFigureOut">
              <a:rPr lang="it-IT" smtClean="0"/>
              <a:t>11/08/23</a:t>
            </a:fld>
            <a:endParaRPr lang="it-IT" dirty="0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E76CE21-12DD-D080-64D2-1BFB816BF4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8C2ED1E-AEA2-92D5-1716-74D778A327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AF65E-4640-4E49-A662-37B11C382FE0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0778407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2C5853F-9799-3664-BF0F-1EB4FB2468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0103D794-4001-68F1-25D2-D25D7D1EC5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B994EE74-8204-EFB7-C642-9D3F0137EE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933852BD-7829-E688-51E0-7D2B3A95942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F999CC8F-A950-B039-DF50-02C98E81EE0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6B3A1568-35E1-C744-98BA-B33A0ABAD3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3BC50-C58B-A94F-AD0C-E7543555C2CA}" type="datetimeFigureOut">
              <a:rPr lang="it-IT" smtClean="0"/>
              <a:t>11/08/23</a:t>
            </a:fld>
            <a:endParaRPr lang="it-IT" dirty="0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A58F9D48-1BA7-BC4C-C6F5-327DEEA5BD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8D8D38EF-D7F2-7E50-0458-30A61CC716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AF65E-4640-4E49-A662-37B11C382FE0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9517604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092ED4C-D769-3B54-0163-B392386AE1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511C2791-B31E-0BF1-A836-D0BEFBCD31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3BC50-C58B-A94F-AD0C-E7543555C2CA}" type="datetimeFigureOut">
              <a:rPr lang="it-IT" smtClean="0"/>
              <a:t>11/08/23</a:t>
            </a:fld>
            <a:endParaRPr lang="it-IT" dirty="0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34C5FB06-7594-3C5A-B591-D8A80C99C9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345A904A-D053-5EEC-09E4-7663506821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AF65E-4640-4E49-A662-37B11C382FE0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42288531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E5B0B667-5F6B-ECB0-0D20-654DA21A66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3BC50-C58B-A94F-AD0C-E7543555C2CA}" type="datetimeFigureOut">
              <a:rPr lang="it-IT" smtClean="0"/>
              <a:t>11/08/23</a:t>
            </a:fld>
            <a:endParaRPr lang="it-IT" dirty="0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4CA76439-557B-3ACF-9D0F-C2C1092B54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FF253A33-CE7D-02CD-639D-27A459558B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AF65E-4640-4E49-A662-37B11C382FE0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7801647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ECB9D7E-75AC-1330-8353-473B6CE0D1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53932C1-04AA-3442-881B-898504C374F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7FB31037-4DAF-0CA9-6926-4780D2ABD7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F206999-386A-A72D-3545-A0E01EE40C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3BC50-C58B-A94F-AD0C-E7543555C2CA}" type="datetimeFigureOut">
              <a:rPr lang="it-IT" smtClean="0"/>
              <a:t>11/08/23</a:t>
            </a:fld>
            <a:endParaRPr lang="it-IT" dirty="0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F9F5637-89AF-4A55-5746-BB42575451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0C8D8F8-76C3-CFAE-4B96-636937D9A3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AF65E-4640-4E49-A662-37B11C382FE0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1433606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4A7FBBD-AC99-21BF-C348-FABC25C19E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65C77DC4-FA92-7981-AA4A-BEC8E047B27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 dirty="0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301F5E1D-3766-7881-F953-5550759E0B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CDACB90-B23B-B875-3C00-37DF7CB5B3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83BC50-C58B-A94F-AD0C-E7543555C2CA}" type="datetimeFigureOut">
              <a:rPr lang="it-IT" smtClean="0"/>
              <a:t>11/08/23</a:t>
            </a:fld>
            <a:endParaRPr lang="it-IT" dirty="0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8A208B0-BB6E-804B-B6AF-766C3F63FB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F6CE78D-9BD1-FF12-891A-91291B7260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EAF65E-4640-4E49-A662-37B11C382FE0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7319244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3E709C7E-D60C-F978-712D-9DA3708459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0D5E9D9E-AB99-E993-E235-847190CB73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CFAA626-A196-9FBF-9373-2E4DBB5B7B5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83BC50-C58B-A94F-AD0C-E7543555C2CA}" type="datetimeFigureOut">
              <a:rPr lang="it-IT" smtClean="0"/>
              <a:t>11/08/23</a:t>
            </a:fld>
            <a:endParaRPr lang="it-IT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DBB80C4-81CD-D9DB-6D48-78952643571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7404B2C-40C4-9D45-08F5-482A1E567C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EAF65E-4640-4E49-A662-37B11C382FE0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6317050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uppo 17"/>
          <p:cNvGrpSpPr/>
          <p:nvPr/>
        </p:nvGrpSpPr>
        <p:grpSpPr>
          <a:xfrm>
            <a:off x="981348" y="982831"/>
            <a:ext cx="10757611" cy="2539094"/>
            <a:chOff x="981348" y="982831"/>
            <a:chExt cx="10757611" cy="2539094"/>
          </a:xfrm>
        </p:grpSpPr>
        <p:grpSp>
          <p:nvGrpSpPr>
            <p:cNvPr id="10" name="Gruppo 9"/>
            <p:cNvGrpSpPr/>
            <p:nvPr/>
          </p:nvGrpSpPr>
          <p:grpSpPr>
            <a:xfrm>
              <a:off x="981348" y="982831"/>
              <a:ext cx="10757611" cy="2539094"/>
              <a:chOff x="160735" y="783540"/>
              <a:chExt cx="10757611" cy="2539094"/>
            </a:xfrm>
          </p:grpSpPr>
          <p:pic>
            <p:nvPicPr>
              <p:cNvPr id="5" name="Immagine 4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297"/>
              <a:stretch/>
            </p:blipFill>
            <p:spPr>
              <a:xfrm>
                <a:off x="160735" y="795264"/>
                <a:ext cx="3554116" cy="2418778"/>
              </a:xfrm>
              <a:prstGeom prst="rect">
                <a:avLst/>
              </a:prstGeom>
            </p:spPr>
          </p:pic>
          <p:pic>
            <p:nvPicPr>
              <p:cNvPr id="7" name="Immagine 6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68" t="343" r="-468" b="-4474"/>
              <a:stretch/>
            </p:blipFill>
            <p:spPr>
              <a:xfrm>
                <a:off x="3767609" y="795263"/>
                <a:ext cx="3554116" cy="2527371"/>
              </a:xfrm>
              <a:prstGeom prst="rect">
                <a:avLst/>
              </a:prstGeom>
            </p:spPr>
          </p:pic>
          <p:pic>
            <p:nvPicPr>
              <p:cNvPr id="9" name="Immagine 8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364229" y="783540"/>
                <a:ext cx="3554117" cy="2418779"/>
              </a:xfrm>
              <a:prstGeom prst="rect">
                <a:avLst/>
              </a:prstGeom>
            </p:spPr>
          </p:pic>
        </p:grpSp>
        <p:sp>
          <p:nvSpPr>
            <p:cNvPr id="11" name="CasellaDiTesto 10"/>
            <p:cNvSpPr txBox="1"/>
            <p:nvPr/>
          </p:nvSpPr>
          <p:spPr>
            <a:xfrm>
              <a:off x="4196858" y="3036277"/>
              <a:ext cx="22274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/>
                <a:t>a</a:t>
              </a:r>
            </a:p>
          </p:txBody>
        </p:sp>
        <p:sp>
          <p:nvSpPr>
            <p:cNvPr id="12" name="CasellaDiTesto 11"/>
            <p:cNvSpPr txBox="1"/>
            <p:nvPr/>
          </p:nvSpPr>
          <p:spPr>
            <a:xfrm>
              <a:off x="7831014" y="3048001"/>
              <a:ext cx="22274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/>
                <a:t>b</a:t>
              </a:r>
            </a:p>
          </p:txBody>
        </p:sp>
        <p:sp>
          <p:nvSpPr>
            <p:cNvPr id="13" name="CasellaDiTesto 12"/>
            <p:cNvSpPr txBox="1"/>
            <p:nvPr/>
          </p:nvSpPr>
          <p:spPr>
            <a:xfrm>
              <a:off x="11408576" y="2985216"/>
              <a:ext cx="22274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400" b="1" dirty="0"/>
                <a:t>c</a:t>
              </a:r>
            </a:p>
          </p:txBody>
        </p:sp>
      </p:grp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A3E27052-1738-B1D3-28D7-B070B24293C4}"/>
              </a:ext>
            </a:extLst>
          </p:cNvPr>
          <p:cNvSpPr txBox="1"/>
          <p:nvPr/>
        </p:nvSpPr>
        <p:spPr>
          <a:xfrm>
            <a:off x="873705" y="3522287"/>
            <a:ext cx="10865254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material 1</a:t>
            </a:r>
            <a:endParaRPr lang="it-IT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tumor composed of enlongated GFAP positive cells with regular oval nuclei, interposed occasional granular bodies and a low proliferative index (a, hematoxylin and eosin, original magnification 20X) (b, </a:t>
            </a:r>
            <a:r>
              <a:rPr lang="en-US" kern="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munohistochemistry for GFAP, original magnification 10X) (c, Immunohistochemistry for Ki-67; original magnification 10X).</a:t>
            </a:r>
            <a:endParaRPr lang="it-IT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420468549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61</Words>
  <Application>Microsoft Macintosh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Barbara Castelli</dc:creator>
  <cp:lastModifiedBy>Barbara Castelli</cp:lastModifiedBy>
  <cp:revision>2</cp:revision>
  <dcterms:created xsi:type="dcterms:W3CDTF">2023-08-07T17:38:30Z</dcterms:created>
  <dcterms:modified xsi:type="dcterms:W3CDTF">2023-08-11T15:51:46Z</dcterms:modified>
</cp:coreProperties>
</file>